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421FE7-C35F-4289-866A-BFF05879D83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00A8C8-1732-44B5-9D41-B909AB18C3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DC6C40-93C4-46F0-BD9C-712B4253420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848BD0-7CAE-4627-AEAB-D6BE9C4C352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E5F2A9-23BC-4D68-95F5-9D9F53D4034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55B86B-80E5-4913-9B99-45237C3E20C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6C7103-DB56-4670-B5F7-B7750742B3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416AE0-E972-4943-8D3F-18429280120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E8E686-ECA6-4DB4-BD8C-74607A3D8F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8062C4-B148-486F-A382-44E908F341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EE35E1-0FCF-41F5-BE7B-D652F28654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36B233-4966-4C34-8276-5AD426437D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72BAC1A-B82C-4540-B1E4-63852A82E1E2}" type="slidenum">
              <a:rPr b="0" lang="en-US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9"/>
          <p:cNvSpPr/>
          <p:nvPr/>
        </p:nvSpPr>
        <p:spPr>
          <a:xfrm>
            <a:off x="2193120" y="5049720"/>
            <a:ext cx="1857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Segoe UI Black"/>
              </a:rPr>
              <a:t>Functional oocytes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2" name="TextBox 18"/>
          <p:cNvSpPr/>
          <p:nvPr/>
        </p:nvSpPr>
        <p:spPr>
          <a:xfrm>
            <a:off x="4496040" y="5049720"/>
            <a:ext cx="2199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Segoe UI Black"/>
              </a:rPr>
              <a:t>Nonfunctional oocytes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43" name="Picture 2" descr="D:\박사과정 2008. 6. 2 ~\Data\Data 정리\박사학위논문\박사학위관련자료들\난자\ttt-4616.jpg"/>
          <p:cNvPicPr/>
          <p:nvPr/>
        </p:nvPicPr>
        <p:blipFill>
          <a:blip r:embed="rId1"/>
          <a:stretch/>
        </p:blipFill>
        <p:spPr>
          <a:xfrm>
            <a:off x="4429080" y="2894040"/>
            <a:ext cx="2630520" cy="1979640"/>
          </a:xfrm>
          <a:prstGeom prst="rect">
            <a:avLst/>
          </a:prstGeom>
          <a:ln w="0">
            <a:noFill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</p:pic>
      <p:pic>
        <p:nvPicPr>
          <p:cNvPr id="44" name="Picture 3" descr="D:\박사과정 2008. 6. 2 ~\Data\Data 정리\박사학위논문\박사학위관련자료들\난자\ttt-4611.jpg"/>
          <p:cNvPicPr/>
          <p:nvPr/>
        </p:nvPicPr>
        <p:blipFill>
          <a:blip r:embed="rId2"/>
          <a:stretch/>
        </p:blipFill>
        <p:spPr>
          <a:xfrm>
            <a:off x="1658880" y="2890800"/>
            <a:ext cx="2629080" cy="1979640"/>
          </a:xfrm>
          <a:prstGeom prst="rect">
            <a:avLst/>
          </a:prstGeom>
          <a:ln w="0">
            <a:noFill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</p:pic>
      <p:sp>
        <p:nvSpPr>
          <p:cNvPr id="45" name="TextBox 18"/>
          <p:cNvSpPr/>
          <p:nvPr/>
        </p:nvSpPr>
        <p:spPr>
          <a:xfrm>
            <a:off x="398880" y="333360"/>
            <a:ext cx="401220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HY견고딕"/>
                <a:ea typeface="HY견고딕"/>
              </a:rPr>
              <a:t>Supplementary Fig S1</a:t>
            </a:r>
            <a:endParaRPr b="0" lang="en-US" sz="2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6" name="TextBox 13"/>
          <p:cNvSpPr/>
          <p:nvPr/>
        </p:nvSpPr>
        <p:spPr>
          <a:xfrm>
            <a:off x="1053720" y="5589720"/>
            <a:ext cx="4312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1. Functional and nonfunctional oocytes 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11-29T01:38:26Z</dcterms:created>
  <dc:creator>미롱</dc:creator>
  <dc:description/>
  <dc:language>en-US</dc:language>
  <cp:lastModifiedBy>mhkang</cp:lastModifiedBy>
  <dcterms:modified xsi:type="dcterms:W3CDTF">2019-07-19T02:30:57Z</dcterms:modified>
  <cp:revision>163</cp:revision>
  <dc:subject/>
  <dc:title>슬라이드 1</dc:title>
</cp:coreProperties>
</file>